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2" d="100"/>
          <a:sy n="72" d="100"/>
        </p:scale>
        <p:origin x="552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8734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3704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2670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431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6958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7506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6521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3093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0603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643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4993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0E8DF-2DAB-48FD-8C5F-D9502524997F}" type="datetimeFigureOut">
              <a:rPr lang="zh-CN" altLang="en-US" smtClean="0"/>
              <a:t>2018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0D87F-3FDF-46DD-BAFE-76C739ACD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0247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587508" y="4015410"/>
            <a:ext cx="9016984" cy="22307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b="1" dirty="0" smtClean="0">
                <a:latin typeface="Arial" panose="020B0604020202020204" pitchFamily="34" charset="0"/>
                <a:ea typeface="Adobe Gothic Std B" panose="020B0800000000000000" pitchFamily="34" charset="-128"/>
                <a:cs typeface="Arial" panose="020B0604020202020204" pitchFamily="34" charset="0"/>
              </a:rPr>
              <a:t>Supplementary Figure 2 </a:t>
            </a:r>
            <a:r>
              <a:rPr lang="en-US" altLang="zh-CN" dirty="0" smtClean="0">
                <a:latin typeface="Arial" panose="020B0604020202020204" pitchFamily="34" charset="0"/>
                <a:ea typeface="Adobe Gothic Std B" panose="020B0800000000000000" pitchFamily="34" charset="-128"/>
                <a:cs typeface="Arial" panose="020B0604020202020204" pitchFamily="34" charset="0"/>
              </a:rPr>
              <a:t>Non-T2DM and T2DM human pancreas. The top line of pictures showed the insulin (green) and glucagon (red) in non-T2DM human pancreas. The lower line of pictures showed the insulin (green) and glucagon (red) in T2DM human pancreas. n=3 in each group. T2DM, Type 2 Diabetic Mellitus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4758" y="432481"/>
            <a:ext cx="8203349" cy="32118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85427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dobe Gothic Std B</vt:lpstr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>chin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3</cp:revision>
  <dcterms:created xsi:type="dcterms:W3CDTF">2018-09-19T01:27:22Z</dcterms:created>
  <dcterms:modified xsi:type="dcterms:W3CDTF">2018-09-19T01:48:27Z</dcterms:modified>
</cp:coreProperties>
</file>